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25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CA935A-40F9-71DC-238A-9493EF6456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01B885-11EC-29B2-ED33-AA894821DA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68FF98-EAC5-5C31-CBFB-92D3F1DA8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F05A9D-CB7D-A89E-4FFE-F918FF73A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0638DC-0D22-6B2D-9F5B-A8B075246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3601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462683-218E-1C1C-32B6-790D6010F1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B57E242-9929-9763-F0E1-62A7C3A8A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9ABE8B-74AA-3E23-34E1-5ADBD978A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F62C8D-EEA2-1F20-FEE6-5DF29FF9E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D80239-F96D-BFB8-222B-E299167D6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8381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CE97D0B-B166-9217-E3DF-2A2EFE128F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0D02B1D-6E3E-D801-994C-3E96C91A17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171A78-2A28-8770-C416-978A4B254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09BA78-8DFC-556F-0F28-43E984DB21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AFE972-C2D9-8A49-E443-9ACE3D204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1779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837477-68C6-9822-556D-C3A3AF993A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8491427-A3EE-A6E1-2830-B0FEEF49AB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0288CC-F376-C490-8E28-9224753E1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DA9B69-A69D-26B8-EBA0-F9F16F835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BB7280-3B3A-C0F1-2A35-2BDB1AC67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074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6899BF-F46B-5AD5-ADE1-1E84790E7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9C7119-5C87-F43B-659B-8469EE8AC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62C0E4-A2C5-BFE3-10B5-D54E148A8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99D812-7694-0137-D592-D5C1236A4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6D2DE5-E79B-5F9C-B05A-9D7833A5D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80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152279-B64D-3DBB-2037-E7396FDC1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F29CC0-657A-DE2B-EF79-ECFFC2F66A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D701527-CCC9-F7F8-E0B3-EDBEE9C09D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5FADD8D-D14D-2CCC-1F00-71AA718DA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B122E5-FC85-A7C0-FECC-2061868AB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B6CF41-EFC7-D7DA-ABC7-B1116D800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2080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459124-E784-B9C8-B94E-41388DF85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980646-F6FB-BAC1-33EB-3ED4CEA920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361B42B-B307-2079-151D-9F2BF5E255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9AC7806-5183-9D86-45D1-974DC45434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CE158DD-3AD5-6703-8DD3-FE76E531A4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7A21240-2179-B67A-410D-831F0780E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F2FF02D-8E16-3B0F-B0D2-CCF531AF2D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F4922AC-759D-A5EC-021B-13241C07C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78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966CFD-7164-6AFA-A086-0826FBDB97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5679F11-97A9-C152-C362-6EF22E0E4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9CE06FC-3675-E44B-708E-DE1DC8180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BF30E7E-0D10-76A3-DBB0-15EE218F8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207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A05889B-1C6E-5DE4-9BEF-C4C84816C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04D0C6D-1F9F-2E70-9F27-66EB62A86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5DDFE7A-D583-5B27-BE1E-9B72BB289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154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C42DAD-587B-11CA-3BDF-02BD394AC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70A92A-26BA-7437-304B-CDE32C5700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EAF01E3-B7F8-B75D-0131-BAD1F63FD5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0FB1525-9E8B-0F17-ECD4-D51409049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30B103-ED21-2B40-5CFA-D1B7F2AB1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C1360D-0A4D-7FAE-5A28-3E5C90BC1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871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783BF1-03C6-0601-43BA-0EB6A8710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FF75652-6682-7B6E-898C-07869F5EFF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0410BD4-DF3A-ADC8-7806-1E7A1175AE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24B1699-66AA-7546-E749-013FFAED9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0DB61C-3DF4-D433-40DB-0E84FB3E0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C060A8-66BC-DDE7-EA37-49E6DE3B3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730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9F53C8B-BBC1-FE31-B973-0C15107533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C2C98B7-C64D-D8F4-8FFC-4BCAFABEF0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0ED91B-054D-2AC8-CFC3-31979790DA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F13BD-23D9-4E01-B6AA-BF6C953AAA2E}" type="datetimeFigureOut">
              <a:rPr lang="zh-CN" altLang="en-US" smtClean="0"/>
              <a:t>2024/6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BC55D1-ECC3-6210-929E-AE4422B25A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E254C3-73C6-A9D2-1E0D-60F6BE73AB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79022-2CA6-41DA-92CC-F0DE6CF38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2632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4D638DF1-DA14-3930-C47B-0FF120C973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4711"/>
            <a:ext cx="18473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5" name="图片 2">
            <a:extLst>
              <a:ext uri="{FF2B5EF4-FFF2-40B4-BE49-F238E27FC236}">
                <a16:creationId xmlns:a16="http://schemas.microsoft.com/office/drawing/2014/main" id="{D4450D68-2F39-B549-7629-B0E605E772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338" y="1191279"/>
            <a:ext cx="7810298" cy="3438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40882B01-DDF8-B08D-8483-4AFFF166B4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6911" y="4630128"/>
            <a:ext cx="6115050" cy="12311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indent="304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. </a:t>
            </a:r>
            <a:r>
              <a:rPr kumimoji="0" lang="en-US" altLang="zh-CN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CA score plot in positive mode and negative mode. PCA score plot of each group in (A)positive mode and (B) negative mode.</a:t>
            </a:r>
            <a:r>
              <a:rPr lang="en-US" altLang="zh-CN" sz="18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K: irrigated water + sprayed water, S: irrigated 0.3% NaCl solution + sprayed water, CC: irrigated water + sprayed water 500 mg L</a:t>
            </a:r>
            <a:r>
              <a:rPr lang="en-US" altLang="zh-CN" sz="1400" baseline="300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zh-CN" sz="1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C, SCC: irrigated 0.3% NaCl solution + sprayed water 500 mg L</a:t>
            </a:r>
            <a:r>
              <a:rPr lang="en-US" altLang="zh-CN" sz="1400" baseline="300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zh-CN" sz="1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C.</a:t>
            </a:r>
          </a:p>
        </p:txBody>
      </p:sp>
    </p:spTree>
    <p:extLst>
      <p:ext uri="{BB962C8B-B14F-4D97-AF65-F5344CB8AC3E}">
        <p14:creationId xmlns:p14="http://schemas.microsoft.com/office/powerpoint/2010/main" val="578378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9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靖欣 霍</dc:creator>
  <cp:lastModifiedBy>靖欣 霍</cp:lastModifiedBy>
  <cp:revision>4</cp:revision>
  <dcterms:created xsi:type="dcterms:W3CDTF">2024-05-29T17:21:34Z</dcterms:created>
  <dcterms:modified xsi:type="dcterms:W3CDTF">2024-06-21T13:12:25Z</dcterms:modified>
</cp:coreProperties>
</file>